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0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8EC20E35-A176-4012-BC5E-935CFFF8708E}" styleName="Mittlere Formatvorlag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878" autoAdjust="0"/>
    <p:restoredTop sz="94660"/>
  </p:normalViewPr>
  <p:slideViewPr>
    <p:cSldViewPr showGuides="1">
      <p:cViewPr varScale="1">
        <p:scale>
          <a:sx n="99" d="100"/>
          <a:sy n="99" d="100"/>
        </p:scale>
        <p:origin x="3102" y="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\\bsw-fs010\userdaten\anh.tran\F82_TAT\FACS\291116_Tabelle%20und%20Abildung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\\bsw-fs010\userdaten\anh.tran\F82_TAT\FACS\291116_Tabelle%20und%20Abildung.xlsx" TargetMode="External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belle4!$Z$17</c:f>
              <c:strCache>
                <c:ptCount val="1"/>
                <c:pt idx="0">
                  <c:v>blood</c:v>
                </c:pt>
              </c:strCache>
            </c:strRef>
          </c:tx>
          <c:spPr>
            <a:solidFill>
              <a:sysClr val="windowText" lastClr="000000"/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Tabelle4!$Y$18:$Y$25</c:f>
              <c:strCache>
                <c:ptCount val="8"/>
                <c:pt idx="0">
                  <c:v>CON-/NaCl</c:v>
                </c:pt>
                <c:pt idx="1">
                  <c:v>CON+/NaCl</c:v>
                </c:pt>
                <c:pt idx="2">
                  <c:v>FUS-/NaCl</c:v>
                </c:pt>
                <c:pt idx="3">
                  <c:v>FUS+/NaCl</c:v>
                </c:pt>
                <c:pt idx="4">
                  <c:v>CON-/LPS</c:v>
                </c:pt>
                <c:pt idx="5">
                  <c:v>CON+/LPS</c:v>
                </c:pt>
                <c:pt idx="6">
                  <c:v>FUS-/LPS</c:v>
                </c:pt>
                <c:pt idx="7">
                  <c:v>FUS+/LPS</c:v>
                </c:pt>
              </c:strCache>
            </c:strRef>
          </c:cat>
          <c:val>
            <c:numRef>
              <c:f>Tabelle4!$Z$18:$Z$25</c:f>
              <c:numCache>
                <c:formatCode>General</c:formatCode>
                <c:ptCount val="8"/>
                <c:pt idx="0">
                  <c:v>6623.8</c:v>
                </c:pt>
                <c:pt idx="1">
                  <c:v>6216.4</c:v>
                </c:pt>
                <c:pt idx="2">
                  <c:v>8777</c:v>
                </c:pt>
                <c:pt idx="3" formatCode="0.0">
                  <c:v>6060</c:v>
                </c:pt>
                <c:pt idx="4">
                  <c:v>7380</c:v>
                </c:pt>
                <c:pt idx="5">
                  <c:v>6012.6</c:v>
                </c:pt>
                <c:pt idx="6">
                  <c:v>10449.4</c:v>
                </c:pt>
                <c:pt idx="7" formatCode="0.0">
                  <c:v>7123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781-4955-8A1A-C93B6B88EC1F}"/>
            </c:ext>
          </c:extLst>
        </c:ser>
        <c:ser>
          <c:idx val="1"/>
          <c:order val="1"/>
          <c:tx>
            <c:strRef>
              <c:f>Tabelle4!$AA$17</c:f>
              <c:strCache>
                <c:ptCount val="1"/>
                <c:pt idx="0">
                  <c:v>mlymph</c:v>
                </c:pt>
              </c:strCache>
            </c:strRef>
          </c:tx>
          <c:spPr>
            <a:solidFill>
              <a:sysClr val="window" lastClr="FFFFFF">
                <a:lumMod val="65000"/>
              </a:sys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Tabelle4!$Y$18:$Y$25</c:f>
              <c:strCache>
                <c:ptCount val="8"/>
                <c:pt idx="0">
                  <c:v>CON-/NaCl</c:v>
                </c:pt>
                <c:pt idx="1">
                  <c:v>CON+/NaCl</c:v>
                </c:pt>
                <c:pt idx="2">
                  <c:v>FUS-/NaCl</c:v>
                </c:pt>
                <c:pt idx="3">
                  <c:v>FUS+/NaCl</c:v>
                </c:pt>
                <c:pt idx="4">
                  <c:v>CON-/LPS</c:v>
                </c:pt>
                <c:pt idx="5">
                  <c:v>CON+/LPS</c:v>
                </c:pt>
                <c:pt idx="6">
                  <c:v>FUS-/LPS</c:v>
                </c:pt>
                <c:pt idx="7">
                  <c:v>FUS+/LPS</c:v>
                </c:pt>
              </c:strCache>
            </c:strRef>
          </c:cat>
          <c:val>
            <c:numRef>
              <c:f>Tabelle4!$AA$18:$AA$25</c:f>
              <c:numCache>
                <c:formatCode>General</c:formatCode>
                <c:ptCount val="8"/>
                <c:pt idx="0">
                  <c:v>4344.2</c:v>
                </c:pt>
                <c:pt idx="1">
                  <c:v>4687.2</c:v>
                </c:pt>
                <c:pt idx="2">
                  <c:v>4591.8</c:v>
                </c:pt>
                <c:pt idx="3" formatCode="0.0">
                  <c:v>4634</c:v>
                </c:pt>
                <c:pt idx="4">
                  <c:v>4203.8</c:v>
                </c:pt>
                <c:pt idx="5">
                  <c:v>4529.2</c:v>
                </c:pt>
                <c:pt idx="6">
                  <c:v>4884</c:v>
                </c:pt>
                <c:pt idx="7" formatCode="0.0">
                  <c:v>44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781-4955-8A1A-C93B6B88EC1F}"/>
            </c:ext>
          </c:extLst>
        </c:ser>
        <c:ser>
          <c:idx val="2"/>
          <c:order val="2"/>
          <c:tx>
            <c:strRef>
              <c:f>Tabelle4!$AB$17</c:f>
              <c:strCache>
                <c:ptCount val="1"/>
                <c:pt idx="0">
                  <c:v>spleen</c:v>
                </c:pt>
              </c:strCache>
            </c:strRef>
          </c:tx>
          <c:spPr>
            <a:solidFill>
              <a:sysClr val="window" lastClr="FFFFFF"/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Tabelle4!$Y$18:$Y$25</c:f>
              <c:strCache>
                <c:ptCount val="8"/>
                <c:pt idx="0">
                  <c:v>CON-/NaCl</c:v>
                </c:pt>
                <c:pt idx="1">
                  <c:v>CON+/NaCl</c:v>
                </c:pt>
                <c:pt idx="2">
                  <c:v>FUS-/NaCl</c:v>
                </c:pt>
                <c:pt idx="3">
                  <c:v>FUS+/NaCl</c:v>
                </c:pt>
                <c:pt idx="4">
                  <c:v>CON-/LPS</c:v>
                </c:pt>
                <c:pt idx="5">
                  <c:v>CON+/LPS</c:v>
                </c:pt>
                <c:pt idx="6">
                  <c:v>FUS-/LPS</c:v>
                </c:pt>
                <c:pt idx="7">
                  <c:v>FUS+/LPS</c:v>
                </c:pt>
              </c:strCache>
            </c:strRef>
          </c:cat>
          <c:val>
            <c:numRef>
              <c:f>Tabelle4!$AB$18:$AB$25</c:f>
              <c:numCache>
                <c:formatCode>0.0</c:formatCode>
                <c:ptCount val="8"/>
                <c:pt idx="0">
                  <c:v>2732.3</c:v>
                </c:pt>
                <c:pt idx="1">
                  <c:v>2790.4</c:v>
                </c:pt>
                <c:pt idx="2">
                  <c:v>2824.8</c:v>
                </c:pt>
                <c:pt idx="3">
                  <c:v>2785</c:v>
                </c:pt>
                <c:pt idx="4">
                  <c:v>2788.9</c:v>
                </c:pt>
                <c:pt idx="5">
                  <c:v>2820.3</c:v>
                </c:pt>
                <c:pt idx="6">
                  <c:v>5435.3</c:v>
                </c:pt>
                <c:pt idx="7">
                  <c:v>3036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781-4955-8A1A-C93B6B88EC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17833728"/>
        <c:axId val="417831376"/>
      </c:barChart>
      <c:catAx>
        <c:axId val="417833728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one"/>
        <c:spPr>
          <a:ln w="15875">
            <a:solidFill>
              <a:schemeClr val="tx1"/>
            </a:solidFill>
          </a:ln>
        </c:spPr>
        <c:crossAx val="417831376"/>
        <c:crosses val="autoZero"/>
        <c:auto val="1"/>
        <c:lblAlgn val="ctr"/>
        <c:lblOffset val="100"/>
        <c:noMultiLvlLbl val="0"/>
      </c:catAx>
      <c:valAx>
        <c:axId val="417831376"/>
        <c:scaling>
          <c:orientation val="minMax"/>
          <c:max val="100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otal</a:t>
                </a:r>
                <a:r>
                  <a:rPr lang="en-US" sz="1200" baseline="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8</a:t>
                </a:r>
                <a:r>
                  <a:rPr lang="en-US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lls </a:t>
                </a:r>
              </a:p>
              <a:p>
                <a:pPr>
                  <a:defRPr sz="12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MFI x 10</a:t>
                </a:r>
                <a:r>
                  <a:rPr lang="en-US" sz="12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de-DE"/>
          </a:p>
        </c:txPr>
        <c:crossAx val="417833728"/>
        <c:crosses val="autoZero"/>
        <c:crossBetween val="between"/>
        <c:dispUnits>
          <c:builtInUnit val="thousands"/>
        </c:dispUnits>
      </c:valAx>
    </c:plotArea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belle4!$Z$4</c:f>
              <c:strCache>
                <c:ptCount val="1"/>
                <c:pt idx="0">
                  <c:v>blood</c:v>
                </c:pt>
              </c:strCache>
            </c:strRef>
          </c:tx>
          <c:spPr>
            <a:solidFill>
              <a:sysClr val="windowText" lastClr="000000"/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Tabelle4!$Y$5:$Y$12</c:f>
              <c:strCache>
                <c:ptCount val="8"/>
                <c:pt idx="0">
                  <c:v>CON-/NaCl</c:v>
                </c:pt>
                <c:pt idx="1">
                  <c:v>CON+/NaCl</c:v>
                </c:pt>
                <c:pt idx="2">
                  <c:v>FUS-/NaCl</c:v>
                </c:pt>
                <c:pt idx="3">
                  <c:v>FUS+/NaCl</c:v>
                </c:pt>
                <c:pt idx="4">
                  <c:v>CON-/LPS</c:v>
                </c:pt>
                <c:pt idx="5">
                  <c:v>CON+/LPS</c:v>
                </c:pt>
                <c:pt idx="6">
                  <c:v>FUS-/LPS</c:v>
                </c:pt>
                <c:pt idx="7">
                  <c:v>FUS+/LPS</c:v>
                </c:pt>
              </c:strCache>
            </c:strRef>
          </c:cat>
          <c:val>
            <c:numRef>
              <c:f>Tabelle4!$Z$5:$Z$12</c:f>
              <c:numCache>
                <c:formatCode>General</c:formatCode>
                <c:ptCount val="8"/>
                <c:pt idx="0">
                  <c:v>2024.4</c:v>
                </c:pt>
                <c:pt idx="1">
                  <c:v>2020.8</c:v>
                </c:pt>
                <c:pt idx="2">
                  <c:v>1936.6</c:v>
                </c:pt>
                <c:pt idx="3">
                  <c:v>2067.6</c:v>
                </c:pt>
                <c:pt idx="4" formatCode="0.0">
                  <c:v>1798</c:v>
                </c:pt>
                <c:pt idx="5">
                  <c:v>1922.8</c:v>
                </c:pt>
                <c:pt idx="6">
                  <c:v>2031.8</c:v>
                </c:pt>
                <c:pt idx="7">
                  <c:v>2178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177-4E2F-80E1-45A3EF050072}"/>
            </c:ext>
          </c:extLst>
        </c:ser>
        <c:ser>
          <c:idx val="1"/>
          <c:order val="1"/>
          <c:tx>
            <c:strRef>
              <c:f>Tabelle4!$AA$4</c:f>
              <c:strCache>
                <c:ptCount val="1"/>
                <c:pt idx="0">
                  <c:v>mlymph</c:v>
                </c:pt>
              </c:strCache>
            </c:strRef>
          </c:tx>
          <c:spPr>
            <a:solidFill>
              <a:sysClr val="window" lastClr="FFFFFF">
                <a:lumMod val="65000"/>
              </a:sysClr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Tabelle4!$Y$5:$Y$12</c:f>
              <c:strCache>
                <c:ptCount val="8"/>
                <c:pt idx="0">
                  <c:v>CON-/NaCl</c:v>
                </c:pt>
                <c:pt idx="1">
                  <c:v>CON+/NaCl</c:v>
                </c:pt>
                <c:pt idx="2">
                  <c:v>FUS-/NaCl</c:v>
                </c:pt>
                <c:pt idx="3">
                  <c:v>FUS+/NaCl</c:v>
                </c:pt>
                <c:pt idx="4">
                  <c:v>CON-/LPS</c:v>
                </c:pt>
                <c:pt idx="5">
                  <c:v>CON+/LPS</c:v>
                </c:pt>
                <c:pt idx="6">
                  <c:v>FUS-/LPS</c:v>
                </c:pt>
                <c:pt idx="7">
                  <c:v>FUS+/LPS</c:v>
                </c:pt>
              </c:strCache>
            </c:strRef>
          </c:cat>
          <c:val>
            <c:numRef>
              <c:f>Tabelle4!$AA$5:$AA$12</c:f>
              <c:numCache>
                <c:formatCode>General</c:formatCode>
                <c:ptCount val="8"/>
                <c:pt idx="0">
                  <c:v>2503.8000000000002</c:v>
                </c:pt>
                <c:pt idx="1">
                  <c:v>2468.6</c:v>
                </c:pt>
                <c:pt idx="2">
                  <c:v>2316.8000000000002</c:v>
                </c:pt>
                <c:pt idx="3" formatCode="0.0">
                  <c:v>2474</c:v>
                </c:pt>
                <c:pt idx="4">
                  <c:v>2385.1999999999998</c:v>
                </c:pt>
                <c:pt idx="5" formatCode="0.0">
                  <c:v>2411</c:v>
                </c:pt>
                <c:pt idx="6">
                  <c:v>2365.4</c:v>
                </c:pt>
                <c:pt idx="7">
                  <c:v>2544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177-4E2F-80E1-45A3EF050072}"/>
            </c:ext>
          </c:extLst>
        </c:ser>
        <c:ser>
          <c:idx val="2"/>
          <c:order val="2"/>
          <c:tx>
            <c:strRef>
              <c:f>Tabelle4!$AB$4</c:f>
              <c:strCache>
                <c:ptCount val="1"/>
                <c:pt idx="0">
                  <c:v>spleen</c:v>
                </c:pt>
              </c:strCache>
            </c:strRef>
          </c:tx>
          <c:spPr>
            <a:solidFill>
              <a:sysClr val="window" lastClr="FFFFFF"/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Tabelle4!$Y$5:$Y$12</c:f>
              <c:strCache>
                <c:ptCount val="8"/>
                <c:pt idx="0">
                  <c:v>CON-/NaCl</c:v>
                </c:pt>
                <c:pt idx="1">
                  <c:v>CON+/NaCl</c:v>
                </c:pt>
                <c:pt idx="2">
                  <c:v>FUS-/NaCl</c:v>
                </c:pt>
                <c:pt idx="3">
                  <c:v>FUS+/NaCl</c:v>
                </c:pt>
                <c:pt idx="4">
                  <c:v>CON-/LPS</c:v>
                </c:pt>
                <c:pt idx="5">
                  <c:v>CON+/LPS</c:v>
                </c:pt>
                <c:pt idx="6">
                  <c:v>FUS-/LPS</c:v>
                </c:pt>
                <c:pt idx="7">
                  <c:v>FUS+/LPS</c:v>
                </c:pt>
              </c:strCache>
            </c:strRef>
          </c:cat>
          <c:val>
            <c:numRef>
              <c:f>Tabelle4!$AB$5:$AB$12</c:f>
              <c:numCache>
                <c:formatCode>General</c:formatCode>
                <c:ptCount val="8"/>
                <c:pt idx="0" formatCode="0.0">
                  <c:v>2509</c:v>
                </c:pt>
                <c:pt idx="1">
                  <c:v>2515.5</c:v>
                </c:pt>
                <c:pt idx="2">
                  <c:v>2818.7</c:v>
                </c:pt>
                <c:pt idx="3">
                  <c:v>2464.4</c:v>
                </c:pt>
                <c:pt idx="4">
                  <c:v>2542.8000000000002</c:v>
                </c:pt>
                <c:pt idx="5">
                  <c:v>2552.4</c:v>
                </c:pt>
                <c:pt idx="6">
                  <c:v>2851.1</c:v>
                </c:pt>
                <c:pt idx="7">
                  <c:v>2701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177-4E2F-80E1-45A3EF0500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20"/>
        <c:axId val="417830200"/>
        <c:axId val="417830592"/>
      </c:barChart>
      <c:catAx>
        <c:axId val="41783020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one"/>
        <c:spPr>
          <a:ln w="15875">
            <a:solidFill>
              <a:schemeClr val="tx1"/>
            </a:solidFill>
          </a:ln>
        </c:spPr>
        <c:crossAx val="417830592"/>
        <c:crosses val="autoZero"/>
        <c:auto val="1"/>
        <c:lblAlgn val="ctr"/>
        <c:lblOffset val="100"/>
        <c:noMultiLvlLbl val="0"/>
      </c:catAx>
      <c:valAx>
        <c:axId val="417830592"/>
        <c:scaling>
          <c:orientation val="minMax"/>
          <c:max val="30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otal CD4</a:t>
                </a:r>
                <a:r>
                  <a:rPr lang="en-US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lls </a:t>
                </a:r>
              </a:p>
              <a:p>
                <a:pPr>
                  <a:defRPr sz="12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MFI x 10</a:t>
                </a:r>
                <a:r>
                  <a:rPr lang="en-US" sz="12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de-DE"/>
          </a:p>
        </c:txPr>
        <c:crossAx val="417830200"/>
        <c:crosses val="autoZero"/>
        <c:crossBetween val="between"/>
        <c:majorUnit val="1000"/>
        <c:dispUnits>
          <c:builtInUnit val="thousands"/>
        </c:dispUnits>
      </c:valAx>
    </c:plotArea>
    <c:plotVisOnly val="1"/>
    <c:dispBlanksAs val="gap"/>
    <c:showDLblsOverMax val="0"/>
  </c:chart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787D5F-8097-4893-9AE7-A02038F13A62}" type="datetimeFigureOut">
              <a:rPr lang="en-GB" smtClean="0"/>
              <a:t>14/07/2020</a:t>
            </a:fld>
            <a:endParaRPr lang="en-GB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625AB9-4AEB-4CE9-9C1E-78A9D9738D4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77781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9F3FC-4D73-4B16-B422-A4EE92173575}" type="datetimeFigureOut">
              <a:rPr lang="en-GB" smtClean="0"/>
              <a:t>14/07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93AF0-03B2-44CA-A8EE-FC90C766563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55589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9F3FC-4D73-4B16-B422-A4EE92173575}" type="datetimeFigureOut">
              <a:rPr lang="en-GB" smtClean="0"/>
              <a:t>14/07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93AF0-03B2-44CA-A8EE-FC90C766563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31374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9F3FC-4D73-4B16-B422-A4EE92173575}" type="datetimeFigureOut">
              <a:rPr lang="en-GB" smtClean="0"/>
              <a:t>14/07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93AF0-03B2-44CA-A8EE-FC90C766563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07829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9F3FC-4D73-4B16-B422-A4EE92173575}" type="datetimeFigureOut">
              <a:rPr lang="en-GB" smtClean="0"/>
              <a:t>14/07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93AF0-03B2-44CA-A8EE-FC90C766563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03571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9F3FC-4D73-4B16-B422-A4EE92173575}" type="datetimeFigureOut">
              <a:rPr lang="en-GB" smtClean="0"/>
              <a:t>14/07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93AF0-03B2-44CA-A8EE-FC90C766563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275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9F3FC-4D73-4B16-B422-A4EE92173575}" type="datetimeFigureOut">
              <a:rPr lang="en-GB" smtClean="0"/>
              <a:t>14/07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93AF0-03B2-44CA-A8EE-FC90C766563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66646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9F3FC-4D73-4B16-B422-A4EE92173575}" type="datetimeFigureOut">
              <a:rPr lang="en-GB" smtClean="0"/>
              <a:t>14/07/2020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93AF0-03B2-44CA-A8EE-FC90C766563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20604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9F3FC-4D73-4B16-B422-A4EE92173575}" type="datetimeFigureOut">
              <a:rPr lang="en-GB" smtClean="0"/>
              <a:t>14/07/2020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93AF0-03B2-44CA-A8EE-FC90C766563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54512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9F3FC-4D73-4B16-B422-A4EE92173575}" type="datetimeFigureOut">
              <a:rPr lang="en-GB" smtClean="0"/>
              <a:t>14/07/2020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93AF0-03B2-44CA-A8EE-FC90C766563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09143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9F3FC-4D73-4B16-B422-A4EE92173575}" type="datetimeFigureOut">
              <a:rPr lang="en-GB" smtClean="0"/>
              <a:t>14/07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93AF0-03B2-44CA-A8EE-FC90C766563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84986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9F3FC-4D73-4B16-B422-A4EE92173575}" type="datetimeFigureOut">
              <a:rPr lang="en-GB" smtClean="0"/>
              <a:t>14/07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93AF0-03B2-44CA-A8EE-FC90C766563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4930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E9F3FC-4D73-4B16-B422-A4EE92173575}" type="datetimeFigureOut">
              <a:rPr lang="en-GB" smtClean="0"/>
              <a:t>14/07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093AF0-03B2-44CA-A8EE-FC90C766563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77300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1" name="Tabelle 30">
            <a:extLst>
              <a:ext uri="{FF2B5EF4-FFF2-40B4-BE49-F238E27FC236}">
                <a16:creationId xmlns:a16="http://schemas.microsoft.com/office/drawing/2014/main" id="{3DC48252-2B93-49A1-BD7A-B767D2E7962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79424164"/>
              </p:ext>
            </p:extLst>
          </p:nvPr>
        </p:nvGraphicFramePr>
        <p:xfrm>
          <a:off x="40860" y="2867537"/>
          <a:ext cx="6776280" cy="141643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9715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0377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0662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0836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08363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1080000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</a:tblGrid>
              <a:tr h="216517"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7"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 </a:t>
                      </a:r>
                      <a:r>
                        <a:rPr lang="de-DE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lues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de-DE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de-DE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de-DE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de-DE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de-DE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de-DE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1051">
                <a:tc gridSpan="2">
                  <a:txBody>
                    <a:bodyPr/>
                    <a:lstStyle/>
                    <a:p>
                      <a:pPr algn="l" fontAlgn="b"/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EM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S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S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PS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S*</a:t>
                      </a:r>
                      <a:r>
                        <a:rPr lang="de-DE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S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S*LPS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S</a:t>
                      </a:r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LPS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S*</a:t>
                      </a:r>
                      <a:r>
                        <a:rPr lang="de-DE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S</a:t>
                      </a:r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LPS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16026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ood</a:t>
                      </a:r>
                      <a:r>
                        <a:rPr lang="de-DE" sz="1200" u="none" strike="noStrike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de-DE" sz="12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3.2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7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7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16026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de-DE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senteric</a:t>
                      </a:r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mph</a:t>
                      </a:r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de</a:t>
                      </a:r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5.2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41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11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09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6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09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8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05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16026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leen 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3.9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2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85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2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1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7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8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01051">
                <a:tc gridSpan="10">
                  <a:txBody>
                    <a:bodyPr/>
                    <a:lstStyle/>
                    <a:p>
                      <a:pPr algn="l" fontAlgn="ctr"/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3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3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3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3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3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3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3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3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32" name="Textfeld 14"/>
          <p:cNvSpPr txBox="1">
            <a:spLocks noChangeArrowheads="1"/>
          </p:cNvSpPr>
          <p:nvPr/>
        </p:nvSpPr>
        <p:spPr bwMode="auto">
          <a:xfrm>
            <a:off x="50056" y="107504"/>
            <a:ext cx="485776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de-DE" altLang="de-DE" sz="1400" b="1" dirty="0">
                <a:latin typeface="Times New Roman" pitchFamily="18" charset="0"/>
                <a:cs typeface="Times New Roman" pitchFamily="18" charset="0"/>
              </a:rPr>
              <a:t>(a)</a:t>
            </a:r>
            <a:endParaRPr lang="en-GB" altLang="de-DE" sz="14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8" name="Gruppieren 7"/>
          <p:cNvGrpSpPr/>
          <p:nvPr/>
        </p:nvGrpSpPr>
        <p:grpSpPr>
          <a:xfrm>
            <a:off x="4521373" y="5652120"/>
            <a:ext cx="2075979" cy="934864"/>
            <a:chOff x="5097437" y="4683385"/>
            <a:chExt cx="2075979" cy="934864"/>
          </a:xfrm>
        </p:grpSpPr>
        <p:sp>
          <p:nvSpPr>
            <p:cNvPr id="35" name="Rechteck 34"/>
            <p:cNvSpPr/>
            <p:nvPr/>
          </p:nvSpPr>
          <p:spPr bwMode="auto">
            <a:xfrm>
              <a:off x="5097437" y="5083468"/>
              <a:ext cx="128588" cy="13017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 sz="1200"/>
            </a:p>
          </p:txBody>
        </p:sp>
        <p:sp>
          <p:nvSpPr>
            <p:cNvPr id="36" name="Rechteck 35"/>
            <p:cNvSpPr/>
            <p:nvPr/>
          </p:nvSpPr>
          <p:spPr bwMode="auto">
            <a:xfrm>
              <a:off x="5097437" y="5415882"/>
              <a:ext cx="131763" cy="1301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 sz="1200"/>
            </a:p>
          </p:txBody>
        </p:sp>
        <p:sp>
          <p:nvSpPr>
            <p:cNvPr id="37" name="Rechteck 36"/>
            <p:cNvSpPr/>
            <p:nvPr/>
          </p:nvSpPr>
          <p:spPr bwMode="auto">
            <a:xfrm>
              <a:off x="5097437" y="4752641"/>
              <a:ext cx="130175" cy="128587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 sz="1200"/>
            </a:p>
          </p:txBody>
        </p:sp>
        <p:sp>
          <p:nvSpPr>
            <p:cNvPr id="38" name="Textfeld 2"/>
            <p:cNvSpPr txBox="1">
              <a:spLocks noChangeArrowheads="1"/>
            </p:cNvSpPr>
            <p:nvPr/>
          </p:nvSpPr>
          <p:spPr bwMode="auto">
            <a:xfrm>
              <a:off x="5205745" y="5341250"/>
              <a:ext cx="72726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200" dirty="0">
                  <a:latin typeface="Times New Roman" pitchFamily="18" charset="0"/>
                  <a:cs typeface="Times New Roman" pitchFamily="18" charset="0"/>
                </a:rPr>
                <a:t>Spleen</a:t>
              </a:r>
              <a:endParaRPr lang="en-GB" altLang="de-DE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9" name="Textfeld 9"/>
            <p:cNvSpPr txBox="1">
              <a:spLocks noChangeArrowheads="1"/>
            </p:cNvSpPr>
            <p:nvPr/>
          </p:nvSpPr>
          <p:spPr bwMode="auto">
            <a:xfrm>
              <a:off x="5205745" y="5002809"/>
              <a:ext cx="196767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200" dirty="0" err="1">
                  <a:latin typeface="Times New Roman" pitchFamily="18" charset="0"/>
                  <a:cs typeface="Times New Roman" pitchFamily="18" charset="0"/>
                </a:rPr>
                <a:t>Mesenteric</a:t>
              </a:r>
              <a:r>
                <a:rPr lang="de-DE" altLang="de-DE" sz="1200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de-DE" altLang="de-DE" sz="1200" dirty="0" err="1">
                  <a:latin typeface="Times New Roman" pitchFamily="18" charset="0"/>
                  <a:cs typeface="Times New Roman" pitchFamily="18" charset="0"/>
                </a:rPr>
                <a:t>lymph</a:t>
              </a:r>
              <a:r>
                <a:rPr lang="de-DE" altLang="de-DE" sz="1200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de-DE" altLang="de-DE" sz="1200" dirty="0" err="1">
                  <a:latin typeface="Times New Roman" pitchFamily="18" charset="0"/>
                  <a:cs typeface="Times New Roman" pitchFamily="18" charset="0"/>
                </a:rPr>
                <a:t>node</a:t>
              </a:r>
              <a:endParaRPr lang="en-GB" altLang="de-DE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0" name="Textfeld 10"/>
            <p:cNvSpPr txBox="1">
              <a:spLocks noChangeArrowheads="1"/>
            </p:cNvSpPr>
            <p:nvPr/>
          </p:nvSpPr>
          <p:spPr bwMode="auto">
            <a:xfrm>
              <a:off x="5205745" y="4683385"/>
              <a:ext cx="71757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200" dirty="0">
                  <a:latin typeface="Times New Roman" pitchFamily="18" charset="0"/>
                  <a:cs typeface="Times New Roman" pitchFamily="18" charset="0"/>
                </a:rPr>
                <a:t>Blood</a:t>
              </a:r>
              <a:endParaRPr lang="en-GB" altLang="de-DE" sz="12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7" name="Gruppieren 6"/>
          <p:cNvGrpSpPr/>
          <p:nvPr/>
        </p:nvGrpSpPr>
        <p:grpSpPr>
          <a:xfrm>
            <a:off x="15580" y="107504"/>
            <a:ext cx="4133500" cy="2688389"/>
            <a:chOff x="-39892" y="515459"/>
            <a:chExt cx="4133500" cy="2688389"/>
          </a:xfrm>
        </p:grpSpPr>
        <p:graphicFrame>
          <p:nvGraphicFramePr>
            <p:cNvPr id="22" name="Diagramm 2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63659530"/>
                </p:ext>
              </p:extLst>
            </p:nvPr>
          </p:nvGraphicFramePr>
          <p:xfrm>
            <a:off x="-39892" y="515459"/>
            <a:ext cx="4115996" cy="207878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1" name="Textfeld 27"/>
            <p:cNvSpPr txBox="1">
              <a:spLocks noChangeArrowheads="1"/>
            </p:cNvSpPr>
            <p:nvPr/>
          </p:nvSpPr>
          <p:spPr bwMode="auto">
            <a:xfrm rot="2700000">
              <a:off x="1181334" y="2588352"/>
              <a:ext cx="81756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200" b="1" dirty="0">
                  <a:latin typeface="Times New Roman" pitchFamily="18" charset="0"/>
                  <a:cs typeface="Times New Roman" pitchFamily="18" charset="0"/>
                </a:rPr>
                <a:t>CON+</a:t>
              </a:r>
              <a:endParaRPr lang="en-GB" altLang="de-DE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2" name="Textfeld 28"/>
            <p:cNvSpPr txBox="1">
              <a:spLocks noChangeArrowheads="1"/>
            </p:cNvSpPr>
            <p:nvPr/>
          </p:nvSpPr>
          <p:spPr bwMode="auto">
            <a:xfrm rot="2700000">
              <a:off x="830084" y="2552199"/>
              <a:ext cx="715962" cy="27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200" b="1" dirty="0">
                  <a:latin typeface="Times New Roman" pitchFamily="18" charset="0"/>
                  <a:cs typeface="Times New Roman" pitchFamily="18" charset="0"/>
                </a:rPr>
                <a:t>CON-</a:t>
              </a:r>
              <a:endParaRPr lang="en-GB" altLang="de-DE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3" name="Textfeld 29"/>
            <p:cNvSpPr txBox="1">
              <a:spLocks noChangeArrowheads="1"/>
            </p:cNvSpPr>
            <p:nvPr/>
          </p:nvSpPr>
          <p:spPr bwMode="auto">
            <a:xfrm rot="2700000">
              <a:off x="1583383" y="2588120"/>
              <a:ext cx="817562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200" b="1" dirty="0">
                  <a:latin typeface="Times New Roman" pitchFamily="18" charset="0"/>
                  <a:cs typeface="Times New Roman" pitchFamily="18" charset="0"/>
                </a:rPr>
                <a:t>FUS-</a:t>
              </a:r>
              <a:endParaRPr lang="en-GB" altLang="de-DE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4" name="Textfeld 30"/>
            <p:cNvSpPr txBox="1">
              <a:spLocks noChangeArrowheads="1"/>
            </p:cNvSpPr>
            <p:nvPr/>
          </p:nvSpPr>
          <p:spPr bwMode="auto">
            <a:xfrm rot="2700000">
              <a:off x="1985434" y="2588352"/>
              <a:ext cx="81756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200" b="1" dirty="0">
                  <a:latin typeface="Times New Roman" pitchFamily="18" charset="0"/>
                  <a:cs typeface="Times New Roman" pitchFamily="18" charset="0"/>
                </a:rPr>
                <a:t>FUS+</a:t>
              </a:r>
              <a:endParaRPr lang="en-GB" altLang="de-DE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" name="Textfeld 31"/>
            <p:cNvSpPr txBox="1">
              <a:spLocks noChangeArrowheads="1"/>
            </p:cNvSpPr>
            <p:nvPr/>
          </p:nvSpPr>
          <p:spPr bwMode="auto">
            <a:xfrm rot="2700000">
              <a:off x="2745514" y="2588352"/>
              <a:ext cx="81756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200" b="1" dirty="0">
                  <a:latin typeface="Times New Roman" pitchFamily="18" charset="0"/>
                  <a:cs typeface="Times New Roman" pitchFamily="18" charset="0"/>
                </a:rPr>
                <a:t>CON+</a:t>
              </a:r>
              <a:endParaRPr lang="en-GB" altLang="de-DE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6" name="Textfeld 32"/>
            <p:cNvSpPr txBox="1">
              <a:spLocks noChangeArrowheads="1"/>
            </p:cNvSpPr>
            <p:nvPr/>
          </p:nvSpPr>
          <p:spPr bwMode="auto">
            <a:xfrm rot="2700000">
              <a:off x="2344913" y="2588120"/>
              <a:ext cx="817562" cy="27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200" b="1" dirty="0">
                  <a:latin typeface="Times New Roman" pitchFamily="18" charset="0"/>
                  <a:cs typeface="Times New Roman" pitchFamily="18" charset="0"/>
                </a:rPr>
                <a:t>CON-</a:t>
              </a:r>
              <a:endParaRPr lang="en-GB" altLang="de-DE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7" name="Textfeld 33"/>
            <p:cNvSpPr txBox="1">
              <a:spLocks noChangeArrowheads="1"/>
            </p:cNvSpPr>
            <p:nvPr/>
          </p:nvSpPr>
          <p:spPr bwMode="auto">
            <a:xfrm rot="2700000">
              <a:off x="3146115" y="2588120"/>
              <a:ext cx="817562" cy="27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200" b="1" dirty="0">
                  <a:latin typeface="Times New Roman" pitchFamily="18" charset="0"/>
                  <a:cs typeface="Times New Roman" pitchFamily="18" charset="0"/>
                </a:rPr>
                <a:t>FUS-</a:t>
              </a:r>
              <a:endParaRPr lang="en-GB" altLang="de-DE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8" name="Textfeld 34"/>
            <p:cNvSpPr txBox="1">
              <a:spLocks noChangeArrowheads="1"/>
            </p:cNvSpPr>
            <p:nvPr/>
          </p:nvSpPr>
          <p:spPr bwMode="auto">
            <a:xfrm rot="2700000">
              <a:off x="3546715" y="2588352"/>
              <a:ext cx="81756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200" b="1" dirty="0">
                  <a:latin typeface="Times New Roman" pitchFamily="18" charset="0"/>
                  <a:cs typeface="Times New Roman" pitchFamily="18" charset="0"/>
                </a:rPr>
                <a:t>FUS+</a:t>
              </a:r>
              <a:endParaRPr lang="en-GB" altLang="de-DE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49" name="Gerade Verbindung 87"/>
            <p:cNvCxnSpPr/>
            <p:nvPr/>
          </p:nvCxnSpPr>
          <p:spPr>
            <a:xfrm>
              <a:off x="980728" y="2918098"/>
              <a:ext cx="140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feld 36"/>
            <p:cNvSpPr txBox="1">
              <a:spLocks noChangeArrowheads="1"/>
            </p:cNvSpPr>
            <p:nvPr/>
          </p:nvSpPr>
          <p:spPr bwMode="auto">
            <a:xfrm>
              <a:off x="1232743" y="2927623"/>
              <a:ext cx="900113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200" b="1" dirty="0">
                  <a:latin typeface="Times New Roman" pitchFamily="18" charset="0"/>
                  <a:cs typeface="Times New Roman" pitchFamily="18" charset="0"/>
                </a:rPr>
                <a:t>NaCl</a:t>
              </a:r>
              <a:endParaRPr lang="en-GB" altLang="de-DE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1" name="Textfeld 37"/>
            <p:cNvSpPr txBox="1">
              <a:spLocks noChangeArrowheads="1"/>
            </p:cNvSpPr>
            <p:nvPr/>
          </p:nvSpPr>
          <p:spPr bwMode="auto">
            <a:xfrm>
              <a:off x="2780928" y="2918098"/>
              <a:ext cx="900112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200" b="1" dirty="0">
                  <a:latin typeface="Times New Roman" pitchFamily="18" charset="0"/>
                  <a:cs typeface="Times New Roman" pitchFamily="18" charset="0"/>
                </a:rPr>
                <a:t>LPS</a:t>
              </a:r>
              <a:endParaRPr lang="en-GB" altLang="de-DE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52" name="Gerade Verbindung 90"/>
            <p:cNvCxnSpPr/>
            <p:nvPr/>
          </p:nvCxnSpPr>
          <p:spPr>
            <a:xfrm>
              <a:off x="2564904" y="2918098"/>
              <a:ext cx="140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" name="Gruppieren 5"/>
          <p:cNvGrpSpPr/>
          <p:nvPr/>
        </p:nvGrpSpPr>
        <p:grpSpPr>
          <a:xfrm>
            <a:off x="70694" y="4499992"/>
            <a:ext cx="4006378" cy="3034699"/>
            <a:chOff x="-4432" y="4886770"/>
            <a:chExt cx="4006378" cy="3034699"/>
          </a:xfrm>
        </p:grpSpPr>
        <p:sp>
          <p:nvSpPr>
            <p:cNvPr id="60" name="Textfeld 8"/>
            <p:cNvSpPr txBox="1">
              <a:spLocks noChangeArrowheads="1"/>
            </p:cNvSpPr>
            <p:nvPr/>
          </p:nvSpPr>
          <p:spPr bwMode="auto">
            <a:xfrm rot="2700000">
              <a:off x="1090656" y="7224034"/>
              <a:ext cx="724106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+</a:t>
              </a:r>
              <a:endParaRPr lang="en-GB" alt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Textfeld 9"/>
            <p:cNvSpPr txBox="1">
              <a:spLocks noChangeArrowheads="1"/>
            </p:cNvSpPr>
            <p:nvPr/>
          </p:nvSpPr>
          <p:spPr bwMode="auto">
            <a:xfrm rot="2700000">
              <a:off x="707017" y="7218502"/>
              <a:ext cx="708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-</a:t>
              </a:r>
              <a:endParaRPr lang="en-GB" alt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Textfeld 10"/>
            <p:cNvSpPr txBox="1">
              <a:spLocks noChangeArrowheads="1"/>
            </p:cNvSpPr>
            <p:nvPr/>
          </p:nvSpPr>
          <p:spPr bwMode="auto">
            <a:xfrm rot="2700000">
              <a:off x="1537585" y="7184813"/>
              <a:ext cx="61317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US-</a:t>
              </a:r>
              <a:endParaRPr lang="en-GB" alt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Textfeld 11"/>
            <p:cNvSpPr txBox="1">
              <a:spLocks noChangeArrowheads="1"/>
            </p:cNvSpPr>
            <p:nvPr/>
          </p:nvSpPr>
          <p:spPr bwMode="auto">
            <a:xfrm rot="2700000">
              <a:off x="1912888" y="7196241"/>
              <a:ext cx="64549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US+</a:t>
              </a:r>
              <a:endParaRPr lang="en-GB" alt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Textfeld 17"/>
            <p:cNvSpPr txBox="1">
              <a:spLocks noChangeArrowheads="1"/>
            </p:cNvSpPr>
            <p:nvPr/>
          </p:nvSpPr>
          <p:spPr bwMode="auto">
            <a:xfrm>
              <a:off x="1240031" y="7644470"/>
              <a:ext cx="67389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aCl</a:t>
              </a:r>
              <a:endParaRPr lang="en-GB" alt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Textfeld 18"/>
            <p:cNvSpPr txBox="1">
              <a:spLocks noChangeArrowheads="1"/>
            </p:cNvSpPr>
            <p:nvPr/>
          </p:nvSpPr>
          <p:spPr bwMode="auto">
            <a:xfrm>
              <a:off x="2970703" y="7644470"/>
              <a:ext cx="67389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PS</a:t>
              </a:r>
              <a:endParaRPr lang="en-GB" alt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72" name="Diagramm 7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03189157"/>
                </p:ext>
              </p:extLst>
            </p:nvPr>
          </p:nvGraphicFramePr>
          <p:xfrm>
            <a:off x="138500" y="4886770"/>
            <a:ext cx="3863446" cy="237626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73" name="Textfeld 8"/>
            <p:cNvSpPr txBox="1">
              <a:spLocks noChangeArrowheads="1"/>
            </p:cNvSpPr>
            <p:nvPr/>
          </p:nvSpPr>
          <p:spPr bwMode="auto">
            <a:xfrm rot="2700000">
              <a:off x="2674832" y="7224034"/>
              <a:ext cx="724106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+</a:t>
              </a:r>
              <a:endParaRPr lang="en-GB" alt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Textfeld 9"/>
            <p:cNvSpPr txBox="1">
              <a:spLocks noChangeArrowheads="1"/>
            </p:cNvSpPr>
            <p:nvPr/>
          </p:nvSpPr>
          <p:spPr bwMode="auto">
            <a:xfrm rot="2700000">
              <a:off x="2291193" y="7218502"/>
              <a:ext cx="70845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-</a:t>
              </a:r>
              <a:endParaRPr lang="en-GB" alt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Textfeld 10"/>
            <p:cNvSpPr txBox="1">
              <a:spLocks noChangeArrowheads="1"/>
            </p:cNvSpPr>
            <p:nvPr/>
          </p:nvSpPr>
          <p:spPr bwMode="auto">
            <a:xfrm rot="2700000">
              <a:off x="3121761" y="7184813"/>
              <a:ext cx="61317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US-</a:t>
              </a:r>
              <a:endParaRPr lang="en-GB" alt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Textfeld 11"/>
            <p:cNvSpPr txBox="1">
              <a:spLocks noChangeArrowheads="1"/>
            </p:cNvSpPr>
            <p:nvPr/>
          </p:nvSpPr>
          <p:spPr bwMode="auto">
            <a:xfrm rot="2700000">
              <a:off x="3497064" y="7196241"/>
              <a:ext cx="64549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US+</a:t>
              </a:r>
              <a:endParaRPr lang="en-GB" alt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9" name="Gerade Verbindung 90"/>
            <p:cNvCxnSpPr/>
            <p:nvPr/>
          </p:nvCxnSpPr>
          <p:spPr>
            <a:xfrm>
              <a:off x="2597938" y="7664215"/>
              <a:ext cx="133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Gerade Verbindung 90"/>
            <p:cNvCxnSpPr/>
            <p:nvPr/>
          </p:nvCxnSpPr>
          <p:spPr>
            <a:xfrm>
              <a:off x="869746" y="7664215"/>
              <a:ext cx="133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Textfeld 14"/>
            <p:cNvSpPr txBox="1">
              <a:spLocks noChangeArrowheads="1"/>
            </p:cNvSpPr>
            <p:nvPr/>
          </p:nvSpPr>
          <p:spPr bwMode="auto">
            <a:xfrm>
              <a:off x="-4432" y="4888223"/>
              <a:ext cx="485776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400" b="1" dirty="0" smtClean="0">
                  <a:latin typeface="Times New Roman" pitchFamily="18" charset="0"/>
                  <a:cs typeface="Times New Roman" pitchFamily="18" charset="0"/>
                </a:rPr>
                <a:t>(b)</a:t>
              </a:r>
              <a:endParaRPr lang="en-GB" altLang="de-DE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aphicFrame>
        <p:nvGraphicFramePr>
          <p:cNvPr id="82" name="Tabelle 81">
            <a:extLst>
              <a:ext uri="{FF2B5EF4-FFF2-40B4-BE49-F238E27FC236}">
                <a16:creationId xmlns:a16="http://schemas.microsoft.com/office/drawing/2014/main" id="{3DC48252-2B93-49A1-BD7A-B767D2E7962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78018849"/>
              </p:ext>
            </p:extLst>
          </p:nvPr>
        </p:nvGraphicFramePr>
        <p:xfrm>
          <a:off x="40860" y="7668344"/>
          <a:ext cx="6776280" cy="141643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9715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0377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0662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0836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08363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1080000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</a:tblGrid>
              <a:tr h="216517"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7"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 </a:t>
                      </a:r>
                      <a:r>
                        <a:rPr lang="de-DE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lues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de-DE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de-DE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de-DE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de-DE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de-DE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de-DE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1051">
                <a:tc gridSpan="2">
                  <a:txBody>
                    <a:bodyPr/>
                    <a:lstStyle/>
                    <a:p>
                      <a:pPr algn="l" fontAlgn="b"/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EM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0" i="0" u="none" strike="noStrike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S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S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PS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S*</a:t>
                      </a:r>
                      <a:r>
                        <a:rPr lang="de-DE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S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S*LPS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S</a:t>
                      </a:r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LPS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S*</a:t>
                      </a:r>
                      <a:r>
                        <a:rPr lang="de-DE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S</a:t>
                      </a:r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LPS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16026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ood</a:t>
                      </a:r>
                      <a:r>
                        <a:rPr lang="de-DE" sz="1200" u="none" strike="noStrike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de-DE" sz="12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6.6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7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4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6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16026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de-DE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senteric</a:t>
                      </a:r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mph</a:t>
                      </a:r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de</a:t>
                      </a:r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.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9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6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2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1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2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45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7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16026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de-DE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leen 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9.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9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59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6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90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7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85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01051">
                <a:tc gridSpan="10">
                  <a:txBody>
                    <a:bodyPr/>
                    <a:lstStyle/>
                    <a:p>
                      <a:pPr algn="l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EM: </a:t>
                      </a:r>
                      <a:r>
                        <a:rPr lang="de-DE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oled</a:t>
                      </a:r>
                      <a:r>
                        <a:rPr lang="de-DE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1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ndard</a:t>
                      </a:r>
                      <a:r>
                        <a:rPr lang="de-DE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1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ror</a:t>
                      </a:r>
                      <a:r>
                        <a:rPr lang="de-DE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1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f</a:t>
                      </a:r>
                      <a:r>
                        <a:rPr lang="de-DE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1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s</a:t>
                      </a:r>
                      <a:r>
                        <a:rPr lang="de-DE" sz="11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3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3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3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3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3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3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3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3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83" name="Textfeld 82"/>
          <p:cNvSpPr txBox="1"/>
          <p:nvPr/>
        </p:nvSpPr>
        <p:spPr>
          <a:xfrm>
            <a:off x="6385054" y="35496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endParaRPr lang="de-D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4" name="Gruppieren 83"/>
          <p:cNvGrpSpPr/>
          <p:nvPr/>
        </p:nvGrpSpPr>
        <p:grpSpPr>
          <a:xfrm>
            <a:off x="4521373" y="971600"/>
            <a:ext cx="2075979" cy="934864"/>
            <a:chOff x="5097437" y="4683385"/>
            <a:chExt cx="2075979" cy="934864"/>
          </a:xfrm>
        </p:grpSpPr>
        <p:sp>
          <p:nvSpPr>
            <p:cNvPr id="85" name="Rechteck 84"/>
            <p:cNvSpPr/>
            <p:nvPr/>
          </p:nvSpPr>
          <p:spPr bwMode="auto">
            <a:xfrm>
              <a:off x="5097437" y="5083468"/>
              <a:ext cx="128588" cy="13017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 sz="1200"/>
            </a:p>
          </p:txBody>
        </p:sp>
        <p:sp>
          <p:nvSpPr>
            <p:cNvPr id="86" name="Rechteck 85"/>
            <p:cNvSpPr/>
            <p:nvPr/>
          </p:nvSpPr>
          <p:spPr bwMode="auto">
            <a:xfrm>
              <a:off x="5097437" y="5415882"/>
              <a:ext cx="131763" cy="1301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 sz="1200"/>
            </a:p>
          </p:txBody>
        </p:sp>
        <p:sp>
          <p:nvSpPr>
            <p:cNvPr id="87" name="Rechteck 86"/>
            <p:cNvSpPr/>
            <p:nvPr/>
          </p:nvSpPr>
          <p:spPr bwMode="auto">
            <a:xfrm>
              <a:off x="5097437" y="4752641"/>
              <a:ext cx="130175" cy="128587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GB" sz="1200"/>
            </a:p>
          </p:txBody>
        </p:sp>
        <p:sp>
          <p:nvSpPr>
            <p:cNvPr id="88" name="Textfeld 2"/>
            <p:cNvSpPr txBox="1">
              <a:spLocks noChangeArrowheads="1"/>
            </p:cNvSpPr>
            <p:nvPr/>
          </p:nvSpPr>
          <p:spPr bwMode="auto">
            <a:xfrm>
              <a:off x="5205745" y="5341250"/>
              <a:ext cx="72726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200" dirty="0">
                  <a:latin typeface="Times New Roman" pitchFamily="18" charset="0"/>
                  <a:cs typeface="Times New Roman" pitchFamily="18" charset="0"/>
                </a:rPr>
                <a:t>Spleen</a:t>
              </a:r>
              <a:endParaRPr lang="en-GB" altLang="de-DE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9" name="Textfeld 9"/>
            <p:cNvSpPr txBox="1">
              <a:spLocks noChangeArrowheads="1"/>
            </p:cNvSpPr>
            <p:nvPr/>
          </p:nvSpPr>
          <p:spPr bwMode="auto">
            <a:xfrm>
              <a:off x="5205745" y="5002809"/>
              <a:ext cx="196767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200" dirty="0" err="1">
                  <a:latin typeface="Times New Roman" pitchFamily="18" charset="0"/>
                  <a:cs typeface="Times New Roman" pitchFamily="18" charset="0"/>
                </a:rPr>
                <a:t>Mesenteric</a:t>
              </a:r>
              <a:r>
                <a:rPr lang="de-DE" altLang="de-DE" sz="1200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de-DE" altLang="de-DE" sz="1200" dirty="0" err="1">
                  <a:latin typeface="Times New Roman" pitchFamily="18" charset="0"/>
                  <a:cs typeface="Times New Roman" pitchFamily="18" charset="0"/>
                </a:rPr>
                <a:t>lymph</a:t>
              </a:r>
              <a:r>
                <a:rPr lang="de-DE" altLang="de-DE" sz="1200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de-DE" altLang="de-DE" sz="1200" dirty="0" err="1">
                  <a:latin typeface="Times New Roman" pitchFamily="18" charset="0"/>
                  <a:cs typeface="Times New Roman" pitchFamily="18" charset="0"/>
                </a:rPr>
                <a:t>node</a:t>
              </a:r>
              <a:endParaRPr lang="en-GB" altLang="de-DE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0" name="Textfeld 10"/>
            <p:cNvSpPr txBox="1">
              <a:spLocks noChangeArrowheads="1"/>
            </p:cNvSpPr>
            <p:nvPr/>
          </p:nvSpPr>
          <p:spPr bwMode="auto">
            <a:xfrm>
              <a:off x="5205745" y="4683385"/>
              <a:ext cx="71757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200" dirty="0">
                  <a:latin typeface="Times New Roman" pitchFamily="18" charset="0"/>
                  <a:cs typeface="Times New Roman" pitchFamily="18" charset="0"/>
                </a:rPr>
                <a:t>Blood</a:t>
              </a:r>
              <a:endParaRPr lang="en-GB" altLang="de-DE" sz="12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650074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Larissa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Larissa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Larissa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Larissa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Larissa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Larissa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9</Words>
  <Application>Microsoft Office PowerPoint</Application>
  <PresentationFormat>Bildschirmpräsentation (4:3)</PresentationFormat>
  <Paragraphs>106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Larissa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ran, Anh Tuan</dc:creator>
  <cp:lastModifiedBy>Klüß, Jeannette</cp:lastModifiedBy>
  <cp:revision>191</cp:revision>
  <dcterms:created xsi:type="dcterms:W3CDTF">2018-04-11T06:47:51Z</dcterms:created>
  <dcterms:modified xsi:type="dcterms:W3CDTF">2020-07-14T09:29:00Z</dcterms:modified>
</cp:coreProperties>
</file>